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68" autoAdjust="0"/>
    <p:restoredTop sz="94660"/>
  </p:normalViewPr>
  <p:slideViewPr>
    <p:cSldViewPr snapToGrid="0">
      <p:cViewPr varScale="1">
        <p:scale>
          <a:sx n="82" d="100"/>
          <a:sy n="82" d="100"/>
        </p:scale>
        <p:origin x="74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F90402-2EBC-4890-BA9C-730378ACC1C8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C996A1-3325-4BCE-A676-9EEF10B28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691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EE58D-20DE-ECC9-9695-23C04B7444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06A722-11B5-073B-A8F0-E4FB505A30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85DABC-0C06-D38F-DC01-45B16D569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7068F-CC0F-817E-2E43-2658B3A2E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DD98F-9E8B-64D2-0A55-18C38B84E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0129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EB4BF-E0B5-DD0A-271A-386680E9A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F28987-5661-1FB0-07CE-53B3372FE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3E4EBE-174D-DB16-90E2-F3880337D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E6B920-EA89-98D3-E626-955CBB5BF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1F7A3-2A95-926D-2040-B8E33B444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070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A7C243-C0A2-5A53-8A37-827EF0072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B9EB2E-62D5-846C-D35D-B632A32A0B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6D2ED7-15AD-792F-B2F1-7F97C0F02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C0536-D967-6D7D-67A8-80B61D063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C561B-C934-B863-4ADB-00DB6B31E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5045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35DCD1-247E-8837-B4E7-85E531C40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40AACC-F8B2-2922-692A-20D7162D1D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6D65DD-89C0-4AC6-2668-AFEF85A75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B7731-BAB6-6FFE-1F58-F48E87F08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4F38BD-3EFA-CEF8-35D5-49FDEE8A3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2486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F43DB-432D-8A34-79F4-9B0DEBD4F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8486E7-7662-B4CD-72EB-570B1E0E69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6291A8-F581-287F-C333-C98069E71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716A75-58C4-500B-BC64-7A1919BAE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22B72-D54F-EC9D-4196-DA6F602DD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1966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1ED11-69D7-16AC-1CAE-B9B114963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73E40F-EF8B-2B6C-B430-7B2646B727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68F6E7-1760-3428-AEC1-D23EA1F410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4E490-13D5-91EE-0FFF-F2D3FB46B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7DE415-DC13-E2C2-C756-4362597CF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55801C-B116-2D68-006B-C706AC2BD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7752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FE10E-F244-AAF7-488F-B3D47C210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F5D652-EC7B-E576-08B4-29E85E92CE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05A59-9878-8054-04BB-C689F24C1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C03569-C66E-C2C6-912E-CAFD3F0CE1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717DF2-1B06-85CB-F29B-9C27A099CA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66A0E9-C908-20E5-18DC-6CF854FB8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DE9FF2-3C39-6764-7951-48D8B56EC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4A9A1A-84CC-92F0-0C08-9EE09878D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08807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8FFB1-E4A3-4B9B-CAC7-A71D3EF4D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291592-63F3-9979-238C-388D97FD6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AF3501-3EA3-88B7-1541-6149DF198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2ED5A6-4407-E340-78AB-8B17396F8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1009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2D4757-B42F-79B1-2C84-8768260B6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853429-6855-0929-4D20-B773BD18A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8B0803-70FA-6D10-95E8-BC0335F21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3571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2237A-53D8-06A8-EE57-1472F538F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E19037-9D98-8DAD-BC61-D06D7026EF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DAA905-AEB1-7C74-34E3-EAAC4DEE60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42194-5987-442B-1764-E5E2F82BD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CC79AD-B791-8A85-4E8A-E56935252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D3AAEF-210F-F8DD-E7C1-595DBDDF0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9696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B59C6-ECB3-0E4C-A519-82F328BDD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EE8F61-9834-4A38-8160-DDC130C7F3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E1B649-AA48-3A34-E9AC-0A67A44C9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D9E41D-FF98-6002-DE41-4D3C66E2E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303D37-50A4-9EE1-EFEF-900F6379C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2918A-DC51-76B6-9AF5-DC59E48A7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50173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3593D5-6C17-E8AA-6CD2-4D2891E14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817A2D-DA74-0865-252E-5405684F1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D8F7F8-4C81-F060-D4D2-014C0532C0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764F5-5DA8-F300-9A30-7C6DBEF232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8F997-FF39-B6B5-0165-5F383EBA39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5101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328E01-8D7B-4990-C388-374A606D9AF0}"/>
              </a:ext>
            </a:extLst>
          </p:cNvPr>
          <p:cNvSpPr txBox="1"/>
          <p:nvPr/>
        </p:nvSpPr>
        <p:spPr>
          <a:xfrm>
            <a:off x="2766856" y="899526"/>
            <a:ext cx="29867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vine Rotavirus VP6 Forward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CD5C219F-750B-AB10-5AFE-4ED7D65EE117}"/>
              </a:ext>
            </a:extLst>
          </p:cNvPr>
          <p:cNvCxnSpPr>
            <a:cxnSpLocks/>
          </p:cNvCxnSpPr>
          <p:nvPr/>
        </p:nvCxnSpPr>
        <p:spPr>
          <a:xfrm>
            <a:off x="5791670" y="1070767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DE67740-481C-5F2A-8847-8F4A031BD814}"/>
              </a:ext>
            </a:extLst>
          </p:cNvPr>
          <p:cNvSpPr txBox="1"/>
          <p:nvPr/>
        </p:nvSpPr>
        <p:spPr>
          <a:xfrm>
            <a:off x="6269858" y="899526"/>
            <a:ext cx="29979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vine Rotavirus VP6 Revers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1B4C7C4A-6C63-F543-1A72-8CCD1037BEDF}"/>
              </a:ext>
            </a:extLst>
          </p:cNvPr>
          <p:cNvCxnSpPr>
            <a:cxnSpLocks/>
          </p:cNvCxnSpPr>
          <p:nvPr/>
        </p:nvCxnSpPr>
        <p:spPr>
          <a:xfrm>
            <a:off x="6081230" y="1070767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2EF7CD48-AA1A-D1AA-C29D-D8F22F436573}"/>
              </a:ext>
            </a:extLst>
          </p:cNvPr>
          <p:cNvCxnSpPr>
            <a:cxnSpLocks/>
          </p:cNvCxnSpPr>
          <p:nvPr/>
        </p:nvCxnSpPr>
        <p:spPr>
          <a:xfrm>
            <a:off x="5810474" y="2817889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0AF6D3C7-D877-DB08-84BD-3C68B7D64CEF}"/>
              </a:ext>
            </a:extLst>
          </p:cNvPr>
          <p:cNvCxnSpPr>
            <a:cxnSpLocks/>
          </p:cNvCxnSpPr>
          <p:nvPr/>
        </p:nvCxnSpPr>
        <p:spPr>
          <a:xfrm>
            <a:off x="6072602" y="2817889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図 16">
            <a:extLst>
              <a:ext uri="{FF2B5EF4-FFF2-40B4-BE49-F238E27FC236}">
                <a16:creationId xmlns:a16="http://schemas.microsoft.com/office/drawing/2014/main" id="{389F7454-95DD-FD92-38EA-AE5E40AD61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4142" y="1707711"/>
            <a:ext cx="8460762" cy="826689"/>
          </a:xfrm>
          <a:prstGeom prst="rect">
            <a:avLst/>
          </a:prstGeom>
        </p:spPr>
      </p:pic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999AA32E-1EC7-2003-A364-7957067A1B8D}"/>
              </a:ext>
            </a:extLst>
          </p:cNvPr>
          <p:cNvCxnSpPr/>
          <p:nvPr/>
        </p:nvCxnSpPr>
        <p:spPr>
          <a:xfrm flipH="1">
            <a:off x="5791514" y="1037834"/>
            <a:ext cx="0" cy="684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99970173-3ED8-5E85-FA9F-79024C2F8562}"/>
              </a:ext>
            </a:extLst>
          </p:cNvPr>
          <p:cNvCxnSpPr/>
          <p:nvPr/>
        </p:nvCxnSpPr>
        <p:spPr>
          <a:xfrm flipH="1">
            <a:off x="6252602" y="1037833"/>
            <a:ext cx="0" cy="684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906F28ED-1E4E-F9A6-D4DB-1E815580FF54}"/>
              </a:ext>
            </a:extLst>
          </p:cNvPr>
          <p:cNvCxnSpPr/>
          <p:nvPr/>
        </p:nvCxnSpPr>
        <p:spPr>
          <a:xfrm flipH="1">
            <a:off x="5788466" y="2406386"/>
            <a:ext cx="0" cy="432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C604AF05-F8B1-8961-A011-F1F53E08332E}"/>
              </a:ext>
            </a:extLst>
          </p:cNvPr>
          <p:cNvCxnSpPr/>
          <p:nvPr/>
        </p:nvCxnSpPr>
        <p:spPr>
          <a:xfrm flipH="1">
            <a:off x="6253554" y="2406385"/>
            <a:ext cx="0" cy="432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7B459E7-040D-921E-7553-EA52A465AAC5}"/>
              </a:ext>
            </a:extLst>
          </p:cNvPr>
          <p:cNvSpPr txBox="1"/>
          <p:nvPr/>
        </p:nvSpPr>
        <p:spPr>
          <a:xfrm>
            <a:off x="5667774" y="672922"/>
            <a:ext cx="744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.2 kb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8513D29-4199-7716-0F2E-8D7A84382D26}"/>
              </a:ext>
            </a:extLst>
          </p:cNvPr>
          <p:cNvSpPr txBox="1"/>
          <p:nvPr/>
        </p:nvSpPr>
        <p:spPr>
          <a:xfrm>
            <a:off x="5705494" y="2891542"/>
            <a:ext cx="744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.3 kb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107DC40-B187-D51D-4BCC-DF002ACF891E}"/>
              </a:ext>
            </a:extLst>
          </p:cNvPr>
          <p:cNvCxnSpPr/>
          <p:nvPr/>
        </p:nvCxnSpPr>
        <p:spPr>
          <a:xfrm flipH="1">
            <a:off x="7211882" y="2466245"/>
            <a:ext cx="0" cy="1044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CA2DC696-3EDD-EC3E-00F4-CAE5FE85061D}"/>
              </a:ext>
            </a:extLst>
          </p:cNvPr>
          <p:cNvCxnSpPr/>
          <p:nvPr/>
        </p:nvCxnSpPr>
        <p:spPr>
          <a:xfrm flipH="1">
            <a:off x="7718690" y="2466244"/>
            <a:ext cx="0" cy="1044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403C9016-F4A9-112F-A167-8BFF1EBD59D0}"/>
              </a:ext>
            </a:extLst>
          </p:cNvPr>
          <p:cNvCxnSpPr>
            <a:cxnSpLocks/>
          </p:cNvCxnSpPr>
          <p:nvPr/>
        </p:nvCxnSpPr>
        <p:spPr>
          <a:xfrm>
            <a:off x="7215086" y="3485376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F23DD656-6EA2-FAC1-43B1-C06029697639}"/>
              </a:ext>
            </a:extLst>
          </p:cNvPr>
          <p:cNvCxnSpPr>
            <a:cxnSpLocks/>
          </p:cNvCxnSpPr>
          <p:nvPr/>
        </p:nvCxnSpPr>
        <p:spPr>
          <a:xfrm>
            <a:off x="7532078" y="3485376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589F280-0E1A-D091-9FFE-9D4C554D378A}"/>
              </a:ext>
            </a:extLst>
          </p:cNvPr>
          <p:cNvSpPr txBox="1"/>
          <p:nvPr/>
        </p:nvSpPr>
        <p:spPr>
          <a:xfrm>
            <a:off x="7723106" y="3304255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MV2 H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D7A4A02-2364-8A06-9423-1A4506DFECF1}"/>
              </a:ext>
            </a:extLst>
          </p:cNvPr>
          <p:cNvSpPr txBox="1"/>
          <p:nvPr/>
        </p:nvSpPr>
        <p:spPr>
          <a:xfrm>
            <a:off x="7139016" y="3560349"/>
            <a:ext cx="744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.9 kb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C8B9EEB2-59AD-C247-99A4-E62FFF270D1E}"/>
              </a:ext>
            </a:extLst>
          </p:cNvPr>
          <p:cNvCxnSpPr/>
          <p:nvPr/>
        </p:nvCxnSpPr>
        <p:spPr>
          <a:xfrm flipH="1">
            <a:off x="5678710" y="2221194"/>
            <a:ext cx="0" cy="2016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719437D1-7722-4A4F-8E96-E7CBD3725473}"/>
              </a:ext>
            </a:extLst>
          </p:cNvPr>
          <p:cNvCxnSpPr/>
          <p:nvPr/>
        </p:nvCxnSpPr>
        <p:spPr>
          <a:xfrm flipH="1">
            <a:off x="6399833" y="2221193"/>
            <a:ext cx="0" cy="201600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A73E2EE7-2805-C906-3FC4-C13AE779D1C8}"/>
              </a:ext>
            </a:extLst>
          </p:cNvPr>
          <p:cNvCxnSpPr>
            <a:cxnSpLocks/>
          </p:cNvCxnSpPr>
          <p:nvPr/>
        </p:nvCxnSpPr>
        <p:spPr>
          <a:xfrm>
            <a:off x="5674432" y="4181213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0C9A0FE3-82EA-711D-26C6-D81D0977083B}"/>
              </a:ext>
            </a:extLst>
          </p:cNvPr>
          <p:cNvCxnSpPr>
            <a:cxnSpLocks/>
          </p:cNvCxnSpPr>
          <p:nvPr/>
        </p:nvCxnSpPr>
        <p:spPr>
          <a:xfrm>
            <a:off x="6234315" y="4181213"/>
            <a:ext cx="180000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C295AA4-4B76-FA15-F5F0-998288CC174C}"/>
              </a:ext>
            </a:extLst>
          </p:cNvPr>
          <p:cNvSpPr txBox="1"/>
          <p:nvPr/>
        </p:nvSpPr>
        <p:spPr>
          <a:xfrm>
            <a:off x="6425343" y="4000092"/>
            <a:ext cx="11288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DV 618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6824F52-8850-C7EB-6CAE-C18AFEF8C8CB}"/>
              </a:ext>
            </a:extLst>
          </p:cNvPr>
          <p:cNvSpPr txBox="1"/>
          <p:nvPr/>
        </p:nvSpPr>
        <p:spPr>
          <a:xfrm>
            <a:off x="4570358" y="3994164"/>
            <a:ext cx="11288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DV 600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947103A-FE52-E1FF-C8A0-7194E2F0ADD9}"/>
              </a:ext>
            </a:extLst>
          </p:cNvPr>
          <p:cNvSpPr txBox="1"/>
          <p:nvPr/>
        </p:nvSpPr>
        <p:spPr>
          <a:xfrm>
            <a:off x="5273296" y="4358085"/>
            <a:ext cx="15616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nsert + 180 bp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144E3E3-B427-70F3-65A6-D089589E9FBB}"/>
              </a:ext>
            </a:extLst>
          </p:cNvPr>
          <p:cNvSpPr txBox="1"/>
          <p:nvPr/>
        </p:nvSpPr>
        <p:spPr>
          <a:xfrm>
            <a:off x="6145586" y="3298327"/>
            <a:ext cx="1061509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MV2 F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4FBBCC2-249F-F4F4-C9A7-8380C9C8E6A1}"/>
              </a:ext>
            </a:extLst>
          </p:cNvPr>
          <p:cNvSpPr txBox="1"/>
          <p:nvPr/>
        </p:nvSpPr>
        <p:spPr>
          <a:xfrm>
            <a:off x="6261230" y="2646648"/>
            <a:ext cx="299793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vine Rotavirus VP4 Revers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4B1D740-E69B-DDBD-F8F8-6842CBF95A77}"/>
              </a:ext>
            </a:extLst>
          </p:cNvPr>
          <p:cNvSpPr txBox="1"/>
          <p:nvPr/>
        </p:nvSpPr>
        <p:spPr>
          <a:xfrm>
            <a:off x="2758228" y="2646648"/>
            <a:ext cx="298671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vine Rotavirus VP4 Forward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4976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0</TotalTime>
  <Words>34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Rofaida Mostafa</dc:creator>
  <cp:lastModifiedBy>Dr Rofaida Mostafa</cp:lastModifiedBy>
  <cp:revision>241</cp:revision>
  <dcterms:created xsi:type="dcterms:W3CDTF">2023-07-06T13:18:24Z</dcterms:created>
  <dcterms:modified xsi:type="dcterms:W3CDTF">2024-01-20T15:14:13Z</dcterms:modified>
</cp:coreProperties>
</file>